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382" autoAdjust="0"/>
    <p:restoredTop sz="94660"/>
  </p:normalViewPr>
  <p:slideViewPr>
    <p:cSldViewPr snapToGrid="0">
      <p:cViewPr>
        <p:scale>
          <a:sx n="150" d="100"/>
          <a:sy n="150" d="100"/>
        </p:scale>
        <p:origin x="72" y="-12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5E34EC-DBF4-4456-A5CA-E1091F4D662D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5EA7F4-EE8C-4927-B8CA-9030E17B9D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98957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B5EA7F4-EE8C-4927-B8CA-9030E17B9D9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37713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EDD77B-F989-D03B-2B7E-2C8B7C51336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3AC61A2-FF9B-E383-4B62-CF87854C09B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BB02AD-494E-3352-4697-456EE97DF7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834A6-EE55-41C1-94E0-F1BC6939A502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4102EF-25A3-2262-F695-6B510DDA05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E42286-0D73-B08D-A1C0-9D0F2D5875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4563-6699-480C-BCC9-4F8C60C22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1230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6C9D7F-B425-98F4-21A6-9FCFBDB8DE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AAA91FD-F79E-F658-FCB1-B02E05D7C0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BEB651-73D4-F5ED-68EB-760CE5D61E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834A6-EE55-41C1-94E0-F1BC6939A502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5156C9-5292-90DC-5B0B-FACFEA818B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E728BE-E047-75CC-F411-9073617811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4563-6699-480C-BCC9-4F8C60C22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86384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2876707-FDE5-9555-E0DA-4654149648E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CB26A1-43C0-627E-4BDA-14B500EE7B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DC8E70-74AA-372E-BA7F-F708EA51CB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834A6-EE55-41C1-94E0-F1BC6939A502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FFC85A-A340-0CB1-8454-D302EEBA4E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4789B3-5C45-7904-D0B3-6EBD163783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4563-6699-480C-BCC9-4F8C60C22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14641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751AF4-5316-DA26-6A62-D089485CBD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8D5FDE-667E-96EE-08D4-5DDCEB8B94D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D74975-B925-E0DA-37C6-5D8E9E744E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834A6-EE55-41C1-94E0-F1BC6939A502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8CF71D-312E-7134-4B0B-05369B2C3B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E4D391-2609-E592-CBE6-9D756B56CA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4563-6699-480C-BCC9-4F8C60C22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72394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8A9873-17A4-EBE0-A4B1-A71093B625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84C82F-E57A-9263-A70C-B11BBEB050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448139-FCD7-A1CB-DDC5-B0E10CFF08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834A6-EE55-41C1-94E0-F1BC6939A502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B9E1BF-31A5-A9EC-1259-A9AAA3182D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E23B3D-0B49-DFB2-8616-714102BB9C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4563-6699-480C-BCC9-4F8C60C22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835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295508-85C5-2F3F-83C2-B2D3600E17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18E386-4D4D-BBF0-E31B-0BB81C37F7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2B80A38-6154-2019-B35D-BDA5094193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36D43D-6E65-2848-67BC-A78B71D3BB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834A6-EE55-41C1-94E0-F1BC6939A502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933D08-3199-CD71-4682-B6379CD725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CD7A37-6D5F-18E1-F1DC-7B5C8BDF6A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4563-6699-480C-BCC9-4F8C60C22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35418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356FA1-8402-C4D7-44EF-6DCE5A4C21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EC8B76-EAB5-9506-5933-9CB8F597BB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63E570-9A95-6B65-E1B1-A1BD588E85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DDFAC50-9A5C-6DB9-E197-F2613770850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5AC3469-16E3-79B4-0BE4-A70CFCE4C61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866C079-C1A6-2875-9E55-4B8144A9F8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834A6-EE55-41C1-94E0-F1BC6939A502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D164D4A-3B7D-CC4D-A607-7DAFC04227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A79B2F6-83D7-2392-4DFF-677B92A027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4563-6699-480C-BCC9-4F8C60C22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13024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4A52B5-09F0-A854-5A05-010FBB88C7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290F10C-6415-6330-76CD-62729BD6E2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834A6-EE55-41C1-94E0-F1BC6939A502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8B6BE78-E639-A93E-70DC-CD50D99B85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E2924F0-4D1E-620D-8B89-DF69242B2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4563-6699-480C-BCC9-4F8C60C22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84748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D77CF64-673B-F718-38EB-DB8ACEFA3A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834A6-EE55-41C1-94E0-F1BC6939A502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06DFCA3-6108-12CA-17A3-CC9EB67E16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B1BBE44-2574-8C2C-3618-5F98D02697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4563-6699-480C-BCC9-4F8C60C22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2210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AD68FF-50CE-00F6-E95A-5346583114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6CFC71-1B25-D2E9-31E5-1E1EA3DE8E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4414105-B272-4FFC-A665-892451EA2C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B2636B-D0E5-5129-7709-5146C735A2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834A6-EE55-41C1-94E0-F1BC6939A502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C88508E-8654-A942-9C42-C813E8773A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0667AE-2A53-D183-6519-A3BB0780DE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4563-6699-480C-BCC9-4F8C60C22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2145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D1E0D5-D95B-F9E1-BA1D-8A2D645118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36A951F-3191-5C23-CA64-1CA2E4BD110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D9B3E70-86D7-CDD8-570C-1A3E8CB9A0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D7A6D33-C9FA-DBBD-A944-33FBD3E97C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834A6-EE55-41C1-94E0-F1BC6939A502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18EC40-9D89-D234-AAD0-D9D4BCC4C1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1765D5-98A3-6ECB-8594-BE91DB698E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4563-6699-480C-BCC9-4F8C60C22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92788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B0BF71C-268A-E8D9-109E-FB1E99D562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41CE2A-2E46-8CB1-2D28-5C464B307F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B68572-3403-E686-CD48-E075584FA6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10834A6-EE55-41C1-94E0-F1BC6939A502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5E615B-E2F8-76CE-3A64-D54390FA54E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5B9441-0017-CEE4-C9A3-6FC4CB5F318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0A14563-6699-480C-BCC9-4F8C60C22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5879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2741E94-2403-EB43-7ED3-CCF5A169FE7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D68FACFF-0E21-6FC9-DE1C-3473155FD201}"/>
              </a:ext>
            </a:extLst>
          </p:cNvPr>
          <p:cNvSpPr txBox="1"/>
          <p:nvPr/>
        </p:nvSpPr>
        <p:spPr>
          <a:xfrm>
            <a:off x="1294565" y="4372012"/>
            <a:ext cx="9602870" cy="110799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IgA antibodies to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. gonorrhoeae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A antibodies measured by ELISA in pooled sera (3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munization, white bars) (1:50 dilution) and pooled vaginal lavages (dotted bars) (1:20 dilution) from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male BALB/c mice immunized with the 3-Ag vaccine;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emale BALB/c mice immunized with the low-dose 3-Ag vaccine as above, and pooled sera from male BALB/c mice (black bar), or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emale BALB/c mice immunized with the 2-Ag vaccine as above. Samples were tested in triplicate or quadruplicate and values (OD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5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ere expressed as fold-change ± SD relative to the adjuvant alone mice group in each experiment. *, p &lt; 0.05,**, p = 0.001 and *** p &lt; 0.0005 by ordinary one-way ANOVA with Tukey’s multiple comparison’s test. </a:t>
            </a:r>
          </a:p>
        </p:txBody>
      </p:sp>
      <p:pic>
        <p:nvPicPr>
          <p:cNvPr id="5" name="Picture 4" descr="A graph of different types of vaginal lavage&#10;&#10;AI-generated content may be incorrect.">
            <a:extLst>
              <a:ext uri="{FF2B5EF4-FFF2-40B4-BE49-F238E27FC236}">
                <a16:creationId xmlns:a16="http://schemas.microsoft.com/office/drawing/2014/main" id="{6033B80C-5E66-2EF7-F1B1-1D2A1FDAC3D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2668" y="2673096"/>
            <a:ext cx="3026664" cy="15118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53736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441</TotalTime>
  <Words>154</Words>
  <Application>Microsoft Office PowerPoint</Application>
  <PresentationFormat>Widescreen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>Tufts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ssari, Paola</dc:creator>
  <cp:lastModifiedBy>Massari, Paola</cp:lastModifiedBy>
  <cp:revision>77</cp:revision>
  <dcterms:created xsi:type="dcterms:W3CDTF">2025-03-07T14:10:14Z</dcterms:created>
  <dcterms:modified xsi:type="dcterms:W3CDTF">2025-08-19T06:50:34Z</dcterms:modified>
</cp:coreProperties>
</file>